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4059E9-E3AD-41AF-A5A3-B285DFF04253}" v="2" dt="2024-08-01T08:35:03.5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070" y="-2578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AD4059E9-E3AD-41AF-A5A3-B285DFF04253}"/>
    <pc:docChg chg="undo custSel modSld">
      <pc:chgData name="Mireille Vankemmelbeke" userId="e2496c92-8ae2-4817-81db-1e2fdf7923b3" providerId="ADAL" clId="{AD4059E9-E3AD-41AF-A5A3-B285DFF04253}" dt="2024-08-01T08:35:01.238" v="22" actId="1076"/>
      <pc:docMkLst>
        <pc:docMk/>
      </pc:docMkLst>
      <pc:sldChg chg="addSp modSp mod">
        <pc:chgData name="Mireille Vankemmelbeke" userId="e2496c92-8ae2-4817-81db-1e2fdf7923b3" providerId="ADAL" clId="{AD4059E9-E3AD-41AF-A5A3-B285DFF04253}" dt="2024-08-01T08:35:01.238" v="22" actId="1076"/>
        <pc:sldMkLst>
          <pc:docMk/>
          <pc:sldMk cId="868960993" sldId="269"/>
        </pc:sldMkLst>
        <pc:spChg chg="mod">
          <ac:chgData name="Mireille Vankemmelbeke" userId="e2496c92-8ae2-4817-81db-1e2fdf7923b3" providerId="ADAL" clId="{AD4059E9-E3AD-41AF-A5A3-B285DFF04253}" dt="2024-08-01T08:33:45.018" v="17" actId="20577"/>
          <ac:spMkLst>
            <pc:docMk/>
            <pc:sldMk cId="868960993" sldId="269"/>
            <ac:spMk id="7" creationId="{83275967-3BAD-8453-FBF6-8E47B83E5243}"/>
          </ac:spMkLst>
        </pc:spChg>
        <pc:spChg chg="mod">
          <ac:chgData name="Mireille Vankemmelbeke" userId="e2496c92-8ae2-4817-81db-1e2fdf7923b3" providerId="ADAL" clId="{AD4059E9-E3AD-41AF-A5A3-B285DFF04253}" dt="2024-08-01T08:33:51.929" v="18" actId="20577"/>
          <ac:spMkLst>
            <pc:docMk/>
            <pc:sldMk cId="868960993" sldId="269"/>
            <ac:spMk id="14" creationId="{C0AD6B4A-FDED-1CF3-8BBF-3C89DC9125F8}"/>
          </ac:spMkLst>
        </pc:spChg>
        <pc:spChg chg="mod">
          <ac:chgData name="Mireille Vankemmelbeke" userId="e2496c92-8ae2-4817-81db-1e2fdf7923b3" providerId="ADAL" clId="{AD4059E9-E3AD-41AF-A5A3-B285DFF04253}" dt="2024-08-01T08:33:55.402" v="19" actId="20577"/>
          <ac:spMkLst>
            <pc:docMk/>
            <pc:sldMk cId="868960993" sldId="269"/>
            <ac:spMk id="15" creationId="{AAA63D9A-720A-38FA-30FE-B64A03B0D307}"/>
          </ac:spMkLst>
        </pc:spChg>
        <pc:picChg chg="add mod">
          <ac:chgData name="Mireille Vankemmelbeke" userId="e2496c92-8ae2-4817-81db-1e2fdf7923b3" providerId="ADAL" clId="{AD4059E9-E3AD-41AF-A5A3-B285DFF04253}" dt="2024-08-01T08:35:01.238" v="22" actId="1076"/>
          <ac:picMkLst>
            <pc:docMk/>
            <pc:sldMk cId="868960993" sldId="269"/>
            <ac:picMk id="2" creationId="{75DB02E0-0172-574F-2C6B-115E23145954}"/>
          </ac:picMkLst>
        </pc:picChg>
        <pc:picChg chg="mod">
          <ac:chgData name="Mireille Vankemmelbeke" userId="e2496c92-8ae2-4817-81db-1e2fdf7923b3" providerId="ADAL" clId="{AD4059E9-E3AD-41AF-A5A3-B285DFF04253}" dt="2024-08-01T08:33:19.985" v="2" actId="1076"/>
          <ac:picMkLst>
            <pc:docMk/>
            <pc:sldMk cId="868960993" sldId="269"/>
            <ac:picMk id="11" creationId="{1B83C6A4-C081-437D-17C4-D1FA03343D30}"/>
          </ac:picMkLst>
        </pc:picChg>
      </pc:sldChg>
    </pc:docChg>
  </pc:docChgLst>
  <pc:docChgLst>
    <pc:chgData name="Mireille Vankemmelbeke" userId="e2496c92-8ae2-4817-81db-1e2fdf7923b3" providerId="ADAL" clId="{73891AD3-DA0F-4874-8C44-CE770393AFCD}"/>
    <pc:docChg chg="custSel delSld modSld">
      <pc:chgData name="Mireille Vankemmelbeke" userId="e2496c92-8ae2-4817-81db-1e2fdf7923b3" providerId="ADAL" clId="{73891AD3-DA0F-4874-8C44-CE770393AFCD}" dt="2024-06-21T15:44:50.872" v="4" actId="47"/>
      <pc:docMkLst>
        <pc:docMk/>
      </pc:docMkLst>
      <pc:sldChg chg="del">
        <pc:chgData name="Mireille Vankemmelbeke" userId="e2496c92-8ae2-4817-81db-1e2fdf7923b3" providerId="ADAL" clId="{73891AD3-DA0F-4874-8C44-CE770393AFCD}" dt="2024-06-21T15:44:42.021" v="0" actId="47"/>
        <pc:sldMkLst>
          <pc:docMk/>
          <pc:sldMk cId="3935331238" sldId="268"/>
        </pc:sldMkLst>
      </pc:sldChg>
      <pc:sldChg chg="delSp mod">
        <pc:chgData name="Mireille Vankemmelbeke" userId="e2496c92-8ae2-4817-81db-1e2fdf7923b3" providerId="ADAL" clId="{73891AD3-DA0F-4874-8C44-CE770393AFCD}" dt="2024-06-21T15:44:49.221" v="3" actId="478"/>
        <pc:sldMkLst>
          <pc:docMk/>
          <pc:sldMk cId="868960993" sldId="269"/>
        </pc:sldMkLst>
        <pc:spChg chg="del">
          <ac:chgData name="Mireille Vankemmelbeke" userId="e2496c92-8ae2-4817-81db-1e2fdf7923b3" providerId="ADAL" clId="{73891AD3-DA0F-4874-8C44-CE770393AFCD}" dt="2024-06-21T15:44:46.789" v="2" actId="478"/>
          <ac:spMkLst>
            <pc:docMk/>
            <pc:sldMk cId="868960993" sldId="269"/>
            <ac:spMk id="4" creationId="{5E3CACEE-8BE5-F31F-E9D6-FEF2DBE2523D}"/>
          </ac:spMkLst>
        </pc:spChg>
        <pc:spChg chg="del">
          <ac:chgData name="Mireille Vankemmelbeke" userId="e2496c92-8ae2-4817-81db-1e2fdf7923b3" providerId="ADAL" clId="{73891AD3-DA0F-4874-8C44-CE770393AFCD}" dt="2024-06-21T15:44:49.221" v="3" actId="478"/>
          <ac:spMkLst>
            <pc:docMk/>
            <pc:sldMk cId="868960993" sldId="269"/>
            <ac:spMk id="9" creationId="{A86364A3-3171-51B5-56DC-97814CC6E14F}"/>
          </ac:spMkLst>
        </pc:spChg>
        <pc:spChg chg="del">
          <ac:chgData name="Mireille Vankemmelbeke" userId="e2496c92-8ae2-4817-81db-1e2fdf7923b3" providerId="ADAL" clId="{73891AD3-DA0F-4874-8C44-CE770393AFCD}" dt="2024-06-21T15:44:49.221" v="3" actId="478"/>
          <ac:spMkLst>
            <pc:docMk/>
            <pc:sldMk cId="868960993" sldId="269"/>
            <ac:spMk id="10" creationId="{A6EE4B9E-931A-D0B8-45E9-DDDDD02F55DB}"/>
          </ac:spMkLst>
        </pc:spChg>
        <pc:picChg chg="del">
          <ac:chgData name="Mireille Vankemmelbeke" userId="e2496c92-8ae2-4817-81db-1e2fdf7923b3" providerId="ADAL" clId="{73891AD3-DA0F-4874-8C44-CE770393AFCD}" dt="2024-06-21T15:44:45.487" v="1" actId="478"/>
          <ac:picMkLst>
            <pc:docMk/>
            <pc:sldMk cId="868960993" sldId="269"/>
            <ac:picMk id="3" creationId="{07C6B656-125D-EBDD-6A94-0B7A000C716B}"/>
          </ac:picMkLst>
        </pc:picChg>
        <pc:picChg chg="del">
          <ac:chgData name="Mireille Vankemmelbeke" userId="e2496c92-8ae2-4817-81db-1e2fdf7923b3" providerId="ADAL" clId="{73891AD3-DA0F-4874-8C44-CE770393AFCD}" dt="2024-06-21T15:44:49.221" v="3" actId="478"/>
          <ac:picMkLst>
            <pc:docMk/>
            <pc:sldMk cId="868960993" sldId="269"/>
            <ac:picMk id="16" creationId="{436ACC07-BBAC-908B-678D-4EE4BA15215E}"/>
          </ac:picMkLst>
        </pc:picChg>
        <pc:picChg chg="del">
          <ac:chgData name="Mireille Vankemmelbeke" userId="e2496c92-8ae2-4817-81db-1e2fdf7923b3" providerId="ADAL" clId="{73891AD3-DA0F-4874-8C44-CE770393AFCD}" dt="2024-06-21T15:44:49.221" v="3" actId="478"/>
          <ac:picMkLst>
            <pc:docMk/>
            <pc:sldMk cId="868960993" sldId="269"/>
            <ac:picMk id="17" creationId="{BD10C5BA-FE39-7C16-D7AC-4A4000C9580F}"/>
          </ac:picMkLst>
        </pc:picChg>
      </pc:sldChg>
      <pc:sldChg chg="del">
        <pc:chgData name="Mireille Vankemmelbeke" userId="e2496c92-8ae2-4817-81db-1e2fdf7923b3" providerId="ADAL" clId="{73891AD3-DA0F-4874-8C44-CE770393AFCD}" dt="2024-06-21T15:44:50.872" v="4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">
            <a:extLst>
              <a:ext uri="{FF2B5EF4-FFF2-40B4-BE49-F238E27FC236}">
                <a16:creationId xmlns:a16="http://schemas.microsoft.com/office/drawing/2014/main" id="{83275967-3BAD-8453-FBF6-8E47B83E5243}"/>
              </a:ext>
            </a:extLst>
          </p:cNvPr>
          <p:cNvSpPr txBox="1"/>
          <p:nvPr/>
        </p:nvSpPr>
        <p:spPr>
          <a:xfrm>
            <a:off x="100931" y="3737282"/>
            <a:ext cx="6656138" cy="5078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/>
              <a:t>Supplemental Figure 6</a:t>
            </a:r>
            <a:r>
              <a:rPr lang="en-GB" sz="900" dirty="0"/>
              <a:t>. </a:t>
            </a:r>
            <a:r>
              <a:rPr lang="en-GB" sz="900" b="1" dirty="0"/>
              <a:t>A</a:t>
            </a:r>
            <a:r>
              <a:rPr lang="en-GB" sz="900" dirty="0"/>
              <a:t>, Target-dependent multifunctional cytokine production. PBMC and DMS79 cocultured in the presence of 10nM SC134-TCB or B12-TCB for 48 hours.  </a:t>
            </a:r>
            <a:r>
              <a:rPr lang="en-GB" sz="900" b="1" dirty="0"/>
              <a:t>B</a:t>
            </a:r>
            <a:r>
              <a:rPr lang="en-GB" sz="900" dirty="0"/>
              <a:t>, Dose-dependent </a:t>
            </a:r>
            <a:r>
              <a:rPr lang="en-GB" sz="900" dirty="0" err="1"/>
              <a:t>IFNg</a:t>
            </a:r>
            <a:r>
              <a:rPr lang="en-GB" sz="900" dirty="0"/>
              <a:t> production by SC134-TCB, negligible </a:t>
            </a:r>
            <a:r>
              <a:rPr lang="en-GB" sz="900" dirty="0" err="1"/>
              <a:t>IFNg</a:t>
            </a:r>
            <a:r>
              <a:rPr lang="en-GB" sz="900" dirty="0"/>
              <a:t> production by the non-targeting B12-TCB.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625F3AB-E145-5FC1-46A0-49170BFF6139}"/>
              </a:ext>
            </a:extLst>
          </p:cNvPr>
          <p:cNvSpPr txBox="1">
            <a:spLocks/>
          </p:cNvSpPr>
          <p:nvPr/>
        </p:nvSpPr>
        <p:spPr>
          <a:xfrm>
            <a:off x="30481" y="11071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B83C6A4-C081-437D-17C4-D1FA03343D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959" r="-3993"/>
          <a:stretch/>
        </p:blipFill>
        <p:spPr>
          <a:xfrm>
            <a:off x="658369" y="4191128"/>
            <a:ext cx="2519437" cy="180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0AD6B4A-FDED-1CF3-8BBF-3C89DC9125F8}"/>
              </a:ext>
            </a:extLst>
          </p:cNvPr>
          <p:cNvSpPr txBox="1"/>
          <p:nvPr/>
        </p:nvSpPr>
        <p:spPr>
          <a:xfrm>
            <a:off x="3225683" y="4131534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A63D9A-720A-38FA-30FE-B64A03B0D307}"/>
              </a:ext>
            </a:extLst>
          </p:cNvPr>
          <p:cNvSpPr txBox="1"/>
          <p:nvPr/>
        </p:nvSpPr>
        <p:spPr>
          <a:xfrm>
            <a:off x="430668" y="4162014"/>
            <a:ext cx="279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56993332-3CBE-EF21-6E05-DD9C043541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714" t="9282" r="2746" b="19516"/>
          <a:stretch/>
        </p:blipFill>
        <p:spPr>
          <a:xfrm>
            <a:off x="3742690" y="4413250"/>
            <a:ext cx="2391410" cy="1570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96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8-01T08:35:05Z</dcterms:modified>
</cp:coreProperties>
</file>